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  <p:sldId id="262" r:id="rId3"/>
    <p:sldId id="263" r:id="rId4"/>
    <p:sldId id="268" r:id="rId5"/>
    <p:sldId id="27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5F6"/>
    <a:srgbClr val="C561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>
        <p:scale>
          <a:sx n="130" d="100"/>
          <a:sy n="130" d="100"/>
        </p:scale>
        <p:origin x="12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image" Target="../media/image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4452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1618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6397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0040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0020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877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8936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5648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50348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5930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675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563D2-8A12-4311-9E13-4B0E1B1BC65C}" type="datetimeFigureOut">
              <a:rPr lang="en-US" smtClean="0"/>
              <a:t>6/16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F71D6-A34D-488E-A699-2D31133DB4D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3916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w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3.w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D112EE2-1502-2244-B7D7-B2F7F8545F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8326931"/>
              </p:ext>
            </p:extLst>
          </p:nvPr>
        </p:nvGraphicFramePr>
        <p:xfrm>
          <a:off x="425188" y="893679"/>
          <a:ext cx="5915027" cy="876300"/>
        </p:xfrm>
        <a:graphic>
          <a:graphicData uri="http://schemas.openxmlformats.org/drawingml/2006/table">
            <a:tbl>
              <a:tblPr firstRow="1" firstCol="1" bandRow="1"/>
              <a:tblGrid>
                <a:gridCol w="1185107">
                  <a:extLst>
                    <a:ext uri="{9D8B030D-6E8A-4147-A177-3AD203B41FA5}">
                      <a16:colId xmlns:a16="http://schemas.microsoft.com/office/drawing/2014/main" val="2646308477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3737715878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670837893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3329771729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1358587766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1517973747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1707357975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1278001500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1562997885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458409920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929461845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2434256489"/>
                    </a:ext>
                  </a:extLst>
                </a:gridCol>
                <a:gridCol w="394160">
                  <a:extLst>
                    <a:ext uri="{9D8B030D-6E8A-4147-A177-3AD203B41FA5}">
                      <a16:colId xmlns:a16="http://schemas.microsoft.com/office/drawing/2014/main" val="1737984300"/>
                    </a:ext>
                  </a:extLst>
                </a:gridCol>
              </a:tblGrid>
              <a:tr h="15766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W-SLOT #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9328219"/>
                  </a:ext>
                </a:extLst>
              </a:tr>
              <a:tr h="28116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lter Central WL(nm)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350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0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0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5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5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0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0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45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95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0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2761542"/>
                  </a:ext>
                </a:extLst>
              </a:tr>
              <a:tr h="28116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t-on emission label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0</a:t>
                      </a:r>
                      <a:endParaRPr lang="en-IN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1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2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3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-filter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4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5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6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-filter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7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8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9</a:t>
                      </a:r>
                    </a:p>
                  </a:txBody>
                  <a:tcPr marL="47299" marR="4729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345426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1820" y="41018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Table </a:t>
            </a:r>
            <a:r>
              <a:rPr lang="en-US" b="1" dirty="0" smtClean="0"/>
              <a:t>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525326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820" y="4101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</a:t>
            </a:r>
            <a:r>
              <a:rPr lang="en-US" b="1" dirty="0" smtClean="0"/>
              <a:t> S2</a:t>
            </a:r>
            <a:endParaRPr lang="en-US" b="1" dirty="0"/>
          </a:p>
        </p:txBody>
      </p:sp>
      <p:pic>
        <p:nvPicPr>
          <p:cNvPr id="5" name="Mechanical injury_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779990" y="818606"/>
            <a:ext cx="3314376" cy="2856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27451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820" y="4101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3</a:t>
            </a:r>
            <a:endParaRPr lang="en-US" b="1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7E08176-DB4C-4215-948B-910E5D1E9C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8088312"/>
              </p:ext>
            </p:extLst>
          </p:nvPr>
        </p:nvGraphicFramePr>
        <p:xfrm>
          <a:off x="1439863" y="623888"/>
          <a:ext cx="3760787" cy="2906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3" name="Graph" r:id="rId3" imgW="4023360" imgH="3108960" progId="Origin50.Graph">
                  <p:embed/>
                </p:oleObj>
              </mc:Choice>
              <mc:Fallback>
                <p:oleObj name="Graph" r:id="rId3" imgW="4023360" imgH="3108960" progId="Origin50.Graph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37E08176-DB4C-4215-948B-910E5D1E9C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39863" y="623888"/>
                        <a:ext cx="3760787" cy="2906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93769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820" y="-2223217"/>
            <a:ext cx="2292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data 2</a:t>
            </a:r>
            <a:endParaRPr lang="en-US" b="1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E15A9D2-153E-43B1-91A0-10360F5ABA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6292635"/>
              </p:ext>
            </p:extLst>
          </p:nvPr>
        </p:nvGraphicFramePr>
        <p:xfrm>
          <a:off x="858248" y="1055326"/>
          <a:ext cx="4889417" cy="35354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8" r:id="rId3" imgW="5262840" imgH="3805200" progId="">
                  <p:embed/>
                </p:oleObj>
              </mc:Choice>
              <mc:Fallback>
                <p:oleObj r:id="rId3" imgW="5262840" imgH="3805200" progId="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E15A9D2-153E-43B1-91A0-10360F5ABA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58248" y="1055326"/>
                        <a:ext cx="4889417" cy="35354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49EBD66-189D-4F64-85E9-C6E08E15D6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9823874"/>
              </p:ext>
            </p:extLst>
          </p:nvPr>
        </p:nvGraphicFramePr>
        <p:xfrm>
          <a:off x="1168418" y="4364037"/>
          <a:ext cx="4646343" cy="3589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9" name="Graph" r:id="rId5" imgW="4023360" imgH="3108960" progId="Origin50.Graph">
                  <p:embed/>
                </p:oleObj>
              </mc:Choice>
              <mc:Fallback>
                <p:oleObj name="Graph" r:id="rId5" imgW="4023360" imgH="3108960" progId="Origin50.Graph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F49EBD66-189D-4F64-85E9-C6E08E15D6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68418" y="4364037"/>
                        <a:ext cx="4646343" cy="3589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860140" y="119822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860140" y="414527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1820" y="4101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350484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820" y="41018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Table </a:t>
            </a:r>
            <a:r>
              <a:rPr lang="en-US" b="1" dirty="0" smtClean="0"/>
              <a:t>S5</a:t>
            </a:r>
            <a:endParaRPr lang="en-US" b="1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8F7E264-7E7D-C44A-BED9-F690072632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9022432"/>
              </p:ext>
            </p:extLst>
          </p:nvPr>
        </p:nvGraphicFramePr>
        <p:xfrm>
          <a:off x="524858" y="786191"/>
          <a:ext cx="5915028" cy="2332642"/>
        </p:xfrm>
        <a:graphic>
          <a:graphicData uri="http://schemas.openxmlformats.org/drawingml/2006/table">
            <a:tbl>
              <a:tblPr/>
              <a:tblGrid>
                <a:gridCol w="422502">
                  <a:extLst>
                    <a:ext uri="{9D8B030D-6E8A-4147-A177-3AD203B41FA5}">
                      <a16:colId xmlns:a16="http://schemas.microsoft.com/office/drawing/2014/main" val="3255889515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4192198750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4060755066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828039739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713325335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652036275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205090827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2318847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2821862408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645703414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345021383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2178960121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444495897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331972110"/>
                    </a:ext>
                  </a:extLst>
                </a:gridCol>
              </a:tblGrid>
              <a:tr h="169001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MT"/>
                        </a:rPr>
                        <a:t>Band Emissions --&gt;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MT"/>
                        </a:rPr>
                        <a:t>Total Emissions--&gt;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1958440"/>
                  </a:ext>
                </a:extLst>
              </a:tr>
              <a:tr h="178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1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  <a:r>
                        <a:rPr lang="en-IN" sz="10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ilter (1)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  <a:r>
                        <a:rPr lang="en-IN" sz="10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ilter (5)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  <a:r>
                        <a:rPr lang="en-IN" sz="10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ilter (9)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0526459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ntrl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4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3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0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832969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1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44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3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2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5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3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1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9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87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0860607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2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27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8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8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7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7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5930205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3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7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6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3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10078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4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6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7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6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5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576966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5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3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2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3325012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6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1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0581918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7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7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668499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8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2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4324543"/>
                  </a:ext>
                </a:extLst>
              </a:tr>
              <a:tr h="178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9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9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2407183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8F7E264-7E7D-C44A-BED9-F690072632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190168"/>
              </p:ext>
            </p:extLst>
          </p:nvPr>
        </p:nvGraphicFramePr>
        <p:xfrm>
          <a:off x="524858" y="3239061"/>
          <a:ext cx="5915028" cy="2332642"/>
        </p:xfrm>
        <a:graphic>
          <a:graphicData uri="http://schemas.openxmlformats.org/drawingml/2006/table">
            <a:tbl>
              <a:tblPr/>
              <a:tblGrid>
                <a:gridCol w="422502">
                  <a:extLst>
                    <a:ext uri="{9D8B030D-6E8A-4147-A177-3AD203B41FA5}">
                      <a16:colId xmlns:a16="http://schemas.microsoft.com/office/drawing/2014/main" val="3255889515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4192198750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4060755066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828039739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713325335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652036275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205090827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2318847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2821862408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645703414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345021383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2178960121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1444495897"/>
                    </a:ext>
                  </a:extLst>
                </a:gridCol>
                <a:gridCol w="422502">
                  <a:extLst>
                    <a:ext uri="{9D8B030D-6E8A-4147-A177-3AD203B41FA5}">
                      <a16:colId xmlns:a16="http://schemas.microsoft.com/office/drawing/2014/main" val="331972110"/>
                    </a:ext>
                  </a:extLst>
                </a:gridCol>
              </a:tblGrid>
              <a:tr h="169001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MT"/>
                        </a:rPr>
                        <a:t>Band Emissions --&gt;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MT"/>
                        </a:rPr>
                        <a:t>Total Emissions--&gt;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1958440"/>
                  </a:ext>
                </a:extLst>
              </a:tr>
              <a:tr h="178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1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  <a:r>
                        <a:rPr lang="en-IN" sz="10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ilter (1)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  <a:r>
                        <a:rPr lang="en-IN" sz="10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ilter (5)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  <a:r>
                        <a:rPr lang="en-IN" sz="10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filter (9)</a:t>
                      </a:r>
                      <a:endParaRPr lang="en-IN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7042" marR="7042" marT="704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0526459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ntrl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0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832969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1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4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0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92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8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0860607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2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7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8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8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78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5930205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3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7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4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10078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4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6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7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3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576966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5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7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3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3325012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6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5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9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0581918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7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6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3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6684994"/>
                  </a:ext>
                </a:extLst>
              </a:tr>
              <a:tr h="16900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8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4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8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4324543"/>
                  </a:ext>
                </a:extLst>
              </a:tr>
              <a:tr h="17839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9</a:t>
                      </a:r>
                    </a:p>
                  </a:txBody>
                  <a:tcPr marL="7042" marR="7042" marT="704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6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51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</a:rPr>
                        <a:t>7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4</a:t>
                      </a:r>
                    </a:p>
                  </a:txBody>
                  <a:tcPr marL="7042" marR="7042" marT="704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0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9</a:t>
                      </a:r>
                    </a:p>
                  </a:txBody>
                  <a:tcPr marL="7042" marR="7042" marT="704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24071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04240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5</TotalTime>
  <Words>405</Words>
  <Application>Microsoft Office PowerPoint</Application>
  <PresentationFormat>A4 Paper (210x297 mm)</PresentationFormat>
  <Paragraphs>359</Paragraphs>
  <Slides>5</Slides>
  <Notes>0</Notes>
  <HiddenSlides>0</HiddenSlides>
  <MMClips>1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ArialMT</vt:lpstr>
      <vt:lpstr>Calibri</vt:lpstr>
      <vt:lpstr>Calibri Light</vt:lpstr>
      <vt:lpstr>Times New Roman</vt:lpstr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kush Prasad, Ph.D.</dc:creator>
  <cp:lastModifiedBy>Ankush Prasad, Ph.D.</cp:lastModifiedBy>
  <cp:revision>70</cp:revision>
  <dcterms:created xsi:type="dcterms:W3CDTF">2020-04-25T14:08:06Z</dcterms:created>
  <dcterms:modified xsi:type="dcterms:W3CDTF">2020-06-16T14:51:08Z</dcterms:modified>
</cp:coreProperties>
</file>